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77C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8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279282174989353"/>
          <c:y val="0.1032410751287668"/>
          <c:w val="0.86849204845018002"/>
          <c:h val="0.701498527177680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年份</c:v>
                </c:pt>
              </c:strCache>
            </c:strRef>
          </c:tx>
          <c:spPr>
            <a:solidFill>
              <a:srgbClr val="177CB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1A3-492B-B6F2-CFF3AA4B3B07}"/>
              </c:ext>
            </c:extLst>
          </c:dPt>
          <c:dPt>
            <c:idx val="1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1A3-492B-B6F2-CFF3AA4B3B07}"/>
              </c:ext>
            </c:extLst>
          </c:dPt>
          <c:dPt>
            <c:idx val="2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1A3-492B-B6F2-CFF3AA4B3B07}"/>
              </c:ext>
            </c:extLst>
          </c:dPt>
          <c:dPt>
            <c:idx val="4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1A3-492B-B6F2-CFF3AA4B3B07}"/>
              </c:ext>
            </c:extLst>
          </c:dPt>
          <c:dPt>
            <c:idx val="5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1A3-492B-B6F2-CFF3AA4B3B07}"/>
              </c:ext>
            </c:extLst>
          </c:dPt>
          <c:dPt>
            <c:idx val="6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E1A3-492B-B6F2-CFF3AA4B3B07}"/>
              </c:ext>
            </c:extLst>
          </c:dPt>
          <c:dPt>
            <c:idx val="7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E1A3-492B-B6F2-CFF3AA4B3B07}"/>
              </c:ext>
            </c:extLst>
          </c:dPt>
          <c:dPt>
            <c:idx val="8"/>
            <c:invertIfNegative val="0"/>
            <c:bubble3D val="0"/>
            <c:spPr>
              <a:solidFill>
                <a:srgbClr val="177CB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E1A3-492B-B6F2-CFF3AA4B3B0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zh-CN" sz="1400" b="1" i="0" u="none" strike="noStrike" kern="1200" baseline="0">
                    <a:solidFill>
                      <a:srgbClr val="177CB0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2008</c:v>
                </c:pt>
                <c:pt idx="1">
                  <c:v>2012</c:v>
                </c:pt>
                <c:pt idx="2">
                  <c:v>2013</c:v>
                </c:pt>
                <c:pt idx="3">
                  <c:v>2014</c:v>
                </c:pt>
                <c:pt idx="4">
                  <c:v>2015</c:v>
                </c:pt>
                <c:pt idx="5">
                  <c:v>2016</c:v>
                </c:pt>
                <c:pt idx="6">
                  <c:v>2017</c:v>
                </c:pt>
                <c:pt idx="7">
                  <c:v>2018</c:v>
                </c:pt>
                <c:pt idx="8">
                  <c:v>2019</c:v>
                </c:pt>
                <c:pt idx="9">
                  <c:v>2020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2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4</c:v>
                </c:pt>
                <c:pt idx="6">
                  <c:v>5</c:v>
                </c:pt>
                <c:pt idx="7">
                  <c:v>1</c:v>
                </c:pt>
                <c:pt idx="8">
                  <c:v>4</c:v>
                </c:pt>
                <c:pt idx="9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E1A3-492B-B6F2-CFF3AA4B3B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6"/>
        <c:axId val="-100483040"/>
        <c:axId val="-100497184"/>
      </c:barChar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年份2</c:v>
                </c:pt>
              </c:strCache>
            </c:strRef>
          </c:tx>
          <c:spPr>
            <a:ln w="28575" cap="rnd">
              <a:solidFill>
                <a:srgbClr val="177CB0"/>
              </a:solidFill>
              <a:round/>
            </a:ln>
            <a:effectLst/>
          </c:spPr>
          <c:marker>
            <c:symbol val="none"/>
          </c:marker>
          <c:dPt>
            <c:idx val="0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1-B673-4243-8CF8-6CCA81F319B6}"/>
              </c:ext>
            </c:extLst>
          </c:dPt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3-B673-4243-8CF8-6CCA81F319B6}"/>
              </c:ext>
            </c:extLst>
          </c:dPt>
          <c:dPt>
            <c:idx val="2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5-B673-4243-8CF8-6CCA81F319B6}"/>
              </c:ext>
            </c:extLst>
          </c:dPt>
          <c:dPt>
            <c:idx val="4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7-B673-4243-8CF8-6CCA81F319B6}"/>
              </c:ext>
            </c:extLst>
          </c:dPt>
          <c:dPt>
            <c:idx val="5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9-B673-4243-8CF8-6CCA81F319B6}"/>
              </c:ext>
            </c:extLst>
          </c:dPt>
          <c:dPt>
            <c:idx val="6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B-B673-4243-8CF8-6CCA81F319B6}"/>
              </c:ext>
            </c:extLst>
          </c:dPt>
          <c:dPt>
            <c:idx val="7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D-B673-4243-8CF8-6CCA81F319B6}"/>
              </c:ext>
            </c:extLst>
          </c:dPt>
          <c:dPt>
            <c:idx val="8"/>
            <c:marker>
              <c:symbol val="none"/>
            </c:marker>
            <c:bubble3D val="0"/>
            <c:spPr>
              <a:ln w="28575" cap="rnd">
                <a:solidFill>
                  <a:srgbClr val="177CB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F-B673-4243-8CF8-6CCA81F319B6}"/>
              </c:ext>
            </c:extLst>
          </c:dPt>
          <c:cat>
            <c:strRef>
              <c:f>Sheet1!$A$2:$A$11</c:f>
              <c:strCache>
                <c:ptCount val="10"/>
                <c:pt idx="0">
                  <c:v>2008</c:v>
                </c:pt>
                <c:pt idx="1">
                  <c:v>2012</c:v>
                </c:pt>
                <c:pt idx="2">
                  <c:v>2013</c:v>
                </c:pt>
                <c:pt idx="3">
                  <c:v>2014</c:v>
                </c:pt>
                <c:pt idx="4">
                  <c:v>2015</c:v>
                </c:pt>
                <c:pt idx="5">
                  <c:v>2016</c:v>
                </c:pt>
                <c:pt idx="6">
                  <c:v>2017</c:v>
                </c:pt>
                <c:pt idx="7">
                  <c:v>2018</c:v>
                </c:pt>
                <c:pt idx="8">
                  <c:v>2019</c:v>
                </c:pt>
                <c:pt idx="9">
                  <c:v>2020</c:v>
                </c:pt>
              </c:strCache>
            </c:strRef>
          </c:cat>
          <c:val>
            <c:numRef>
              <c:f>Sheet1!$C$2:$C$11</c:f>
              <c:numCache>
                <c:formatCode>General</c:formatCode>
                <c:ptCount val="10"/>
                <c:pt idx="0">
                  <c:v>2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4</c:v>
                </c:pt>
                <c:pt idx="6">
                  <c:v>5</c:v>
                </c:pt>
                <c:pt idx="7">
                  <c:v>1</c:v>
                </c:pt>
                <c:pt idx="8">
                  <c:v>4</c:v>
                </c:pt>
                <c:pt idx="9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E1A3-492B-B6F2-CFF3AA4B3B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00483040"/>
        <c:axId val="-100497184"/>
      </c:lineChart>
      <c:catAx>
        <c:axId val="-1004830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400" b="1" i="0" u="none" strike="noStrike" kern="1200" baseline="0">
                    <a:solidFill>
                      <a:srgbClr val="177CB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/>
                  <a:t>Year</a:t>
                </a:r>
                <a:endParaRPr lang="zh-CN" sz="14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zh-CN" sz="1400" b="1" i="0" u="none" strike="noStrike" kern="1200" baseline="0">
                  <a:solidFill>
                    <a:srgbClr val="177CB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19050" cap="flat" cmpd="sng" algn="ctr">
            <a:solidFill>
              <a:srgbClr val="177CB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400" b="1" i="0" u="none" strike="noStrike" kern="1200" baseline="0">
                <a:solidFill>
                  <a:srgbClr val="177CB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97184"/>
        <c:crossesAt val="0"/>
        <c:auto val="1"/>
        <c:lblAlgn val="ctr"/>
        <c:lblOffset val="100"/>
        <c:noMultiLvlLbl val="0"/>
      </c:catAx>
      <c:valAx>
        <c:axId val="-100497184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400" b="1" i="0" u="none" strike="noStrike" kern="1200" baseline="0">
                    <a:solidFill>
                      <a:srgbClr val="177CB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/>
                  <a:t>Number of Publication</a:t>
                </a:r>
                <a:endParaRPr lang="zh-CN" sz="14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400" b="1" i="0" u="none" strike="noStrike" kern="1200" baseline="0">
                  <a:solidFill>
                    <a:srgbClr val="177CB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solidFill>
            <a:sysClr val="window" lastClr="FFFFFF"/>
          </a:solidFill>
          <a:ln w="19050">
            <a:solidFill>
              <a:srgbClr val="177CB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400" b="1" i="0" u="none" strike="noStrike" kern="1200" baseline="0">
                <a:solidFill>
                  <a:srgbClr val="177CB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100483040"/>
        <c:crosses val="autoZero"/>
        <c:crossBetween val="between"/>
        <c:majorUnit val="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>
          <a:solidFill>
            <a:srgbClr val="177CB0"/>
          </a:solidFill>
        </a:defRPr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rgbClr val="177CB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1400" b="1" i="0" u="none" strike="noStrike" baseline="0" dirty="0">
                <a:solidFill>
                  <a:srgbClr val="177CB0"/>
                </a:solidFill>
                <a:effectLst/>
              </a:rPr>
              <a:t>Institution</a:t>
            </a:r>
            <a:endParaRPr lang="en-US" altLang="zh-CN" sz="1400" dirty="0">
              <a:solidFill>
                <a:srgbClr val="177CB0"/>
              </a:solidFill>
            </a:endParaRPr>
          </a:p>
        </c:rich>
      </c:tx>
      <c:layout>
        <c:manualLayout>
          <c:xMode val="edge"/>
          <c:yMode val="edge"/>
          <c:x val="0.45381665592512682"/>
          <c:y val="4.14830414018575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rgbClr val="177CB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54212087708678314"/>
          <c:y val="0.11152867540827463"/>
          <c:w val="0.39560039155064392"/>
          <c:h val="0.80030241659039281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Instuition</c:v>
                </c:pt>
              </c:strCache>
            </c:strRef>
          </c:tx>
          <c:spPr>
            <a:solidFill>
              <a:srgbClr val="177CB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rgbClr val="177CB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0</c:f>
              <c:strCache>
                <c:ptCount val="9"/>
                <c:pt idx="0">
                  <c:v>Fudan University</c:v>
                </c:pt>
                <c:pt idx="1">
                  <c:v>1st Affiliated Hospital of Beijing University of TCM</c:v>
                </c:pt>
                <c:pt idx="2">
                  <c:v>4th Hospital Affiliated to Jinan University</c:v>
                </c:pt>
                <c:pt idx="3">
                  <c:v>Peking University Shenzhen Hospital</c:v>
                </c:pt>
                <c:pt idx="4">
                  <c:v>2nd Affiliated Hospital of Guangzhou University of TCM</c:v>
                </c:pt>
                <c:pt idx="5">
                  <c:v>Beijing Hospital</c:v>
                </c:pt>
                <c:pt idx="6">
                  <c:v>Xidian University</c:v>
                </c:pt>
                <c:pt idx="7">
                  <c:v>Dongzhimen Hospital of Beijing University of TCM</c:v>
                </c:pt>
                <c:pt idx="8">
                  <c:v>Chengdu University of TCM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5</c:v>
                </c:pt>
                <c:pt idx="8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1C-4374-AD1A-676B423F76AB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80"/>
        <c:axId val="648345760"/>
        <c:axId val="648345344"/>
      </c:barChart>
      <c:catAx>
        <c:axId val="6483457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rgbClr val="177CB0"/>
                </a:solidFill>
                <a:latin typeface="Arial Narrow" panose="020B060602020203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648345344"/>
        <c:crosses val="autoZero"/>
        <c:auto val="1"/>
        <c:lblAlgn val="ctr"/>
        <c:lblOffset val="100"/>
        <c:noMultiLvlLbl val="0"/>
      </c:catAx>
      <c:valAx>
        <c:axId val="648345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altLang="zh-CN" sz="1400" b="1" i="0" u="none" strike="noStrike" kern="1200" spc="0" baseline="0" dirty="0" smtClean="0">
                    <a:solidFill>
                      <a:srgbClr val="177CB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400" b="1" i="0" u="none" strike="noStrike" kern="1200" spc="0" baseline="0" dirty="0">
                    <a:solidFill>
                      <a:srgbClr val="177CB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Number of Publication</a:t>
                </a:r>
              </a:p>
            </c:rich>
          </c:tx>
          <c:layout>
            <c:manualLayout>
              <c:xMode val="edge"/>
              <c:yMode val="edge"/>
              <c:x val="0.52180529638393758"/>
              <c:y val="0.933915333903141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ctr" rtl="0">
                <a:defRPr lang="en-US" altLang="zh-CN" sz="1400" b="1" i="0" u="none" strike="noStrike" kern="1200" spc="0" baseline="0" dirty="0" smtClean="0">
                  <a:solidFill>
                    <a:srgbClr val="177CB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zh-CN"/>
          </a:p>
        </c:txPr>
        <c:crossAx val="648345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6122D5-F857-4E11-AAF6-123C37A4AC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427438A-B7DE-4FDF-9E07-EA5E284BD3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E16D9C-A4E3-48DF-833C-51B6844B4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CDB2A1-25DA-402C-AE5B-2C5F90468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16A2D8-E30F-4493-9555-A7D126FF7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67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D70ABE-6993-4374-9253-6E9B1EF4E1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F0B3B6-CA3D-4E93-B26B-B160E565E8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0C1CC3-E355-48E0-8974-13BC19198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29B6A5-F101-4876-9DA3-06C0C3FEA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CA8BE7-6729-42BF-9F4F-005E2C74E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9584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2F33716-C157-4378-9CEC-AA6C805E64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60001C9-2550-4348-9DBF-95C4981B56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F46436-606C-4692-8FC7-23ACF2B03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F3348E-8C9D-4996-BBBC-0F8AD49D6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31F42B6-9BBD-4789-9418-9BF1C0CA3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80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78CD2C-92B3-486B-A8FA-9AC0769BC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F8FFEB3-B598-48FE-8134-CD62228416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FBABF-BA83-418C-8495-42934BC50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3F9DE7-6ED0-4CCA-86A6-5F643916B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C06819-8D8A-43A4-BA8A-2AF337152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245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BFA9A4-F647-4CAF-86EA-2F2195D09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BCFCC5-B990-4483-9C65-EB407BC651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88C22B-6FDD-422E-ADB6-6B864C232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ECC6A3-7811-479F-931C-1F6535C3E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37C14B-9AD4-4863-9007-A95221323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5065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EB70E4-6085-4BB4-A524-BF367F07AD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0D48361-77CC-4C8E-91BF-C1C69003A9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0D4028D-82FF-4C30-86F4-5443E15256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E9399FF-1815-402C-8A8C-E3759D7AA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069125-0AB6-4B6D-BE88-F7FD728E3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BFC93D-039D-4FCC-8065-B837EDDB8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45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AA3F94-15BE-4418-8DAE-DB2A1FAF1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0606204-4E0B-437C-87B4-1001491008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C8460B5-F080-4606-B854-1276337D34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222F1C4-4074-4BF5-BBF8-D80EE831C3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0FBAA5E-6CEF-4D7C-A12B-8F2FA08531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E9BE47E-5A49-4B71-BB31-F5E50DA0B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1F3C830-7C74-4027-8C7D-1AE19D0CB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71ECBB3-3429-4A16-8D07-B73CCFD4D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710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9F0137-2789-47D8-8F64-EB412784D5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884CCEE-6D43-42D9-BC27-309049A0E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3214AC9-2C49-4C57-9100-885522454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5CB1891-4337-4EE9-BB8B-EDE229F13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6632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E60FFD5-EDF8-4D89-B9B0-65E5CE6E0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67A3769-04B2-43CC-B381-465D22BFB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D20D94C-BD02-4008-BFD5-26BEC4BF8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682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FD96F0-1BF9-442C-84EC-1C775273C1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7D9F24-134B-4FC4-9BCA-87E5C22525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F4412E-9551-41AA-9119-A7C5708C62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0AE471D-4855-45F6-9902-711DBDA24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5949F5B-CF09-4568-B353-B3C301B78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638AC8-CC70-4F7C-9702-C1E9DAEF1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657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4C9A31-8BFF-44A7-BA56-6FD6B9092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425651-5014-400B-8758-51BCF95A8F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6B02ED6-97C9-48A6-A74C-F3F3BD8255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1402CC-7BC1-4FF7-BB5A-B143FB9B4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D3430E7-092F-4628-9055-6418A678A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50AD28-D987-449B-B3A8-81CDFF398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4438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36064B6-90B0-4012-A8C3-0A773DB8B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0A00756-3964-4940-923A-F193C7B9DD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366688-BDB1-4A8C-BF2D-7FDC33BA81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184255-07D5-4CF3-A514-4E1F82069323}" type="datetimeFigureOut">
              <a:rPr lang="zh-CN" altLang="en-US" smtClean="0"/>
              <a:t>2021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1930F2-B356-4097-B7DF-EB1EDD287A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65BB1A-6284-4A0C-B60B-6BBDFA04A5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C7286-BF85-4E11-BF79-7B440B9A11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132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7D31CB3E-A276-40F1-859C-23437407A01E}"/>
              </a:ext>
            </a:extLst>
          </p:cNvPr>
          <p:cNvGrpSpPr/>
          <p:nvPr/>
        </p:nvGrpSpPr>
        <p:grpSpPr>
          <a:xfrm>
            <a:off x="0" y="18703"/>
            <a:ext cx="12999904" cy="5149193"/>
            <a:chOff x="0" y="18703"/>
            <a:chExt cx="12999904" cy="5149193"/>
          </a:xfrm>
        </p:grpSpPr>
        <p:graphicFrame>
          <p:nvGraphicFramePr>
            <p:cNvPr id="8" name="图表 7">
              <a:extLst>
                <a:ext uri="{FF2B5EF4-FFF2-40B4-BE49-F238E27FC236}">
                  <a16:creationId xmlns:a16="http://schemas.microsoft.com/office/drawing/2014/main" id="{3F41B501-5517-4B4A-A467-DA8A6DBE6807}"/>
                </a:ext>
              </a:extLst>
            </p:cNvPr>
            <p:cNvGraphicFramePr/>
            <p:nvPr/>
          </p:nvGraphicFramePr>
          <p:xfrm>
            <a:off x="0" y="101599"/>
            <a:ext cx="5994400" cy="408980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" name="图表 9">
              <a:extLst>
                <a:ext uri="{FF2B5EF4-FFF2-40B4-BE49-F238E27FC236}">
                  <a16:creationId xmlns:a16="http://schemas.microsoft.com/office/drawing/2014/main" id="{8A046580-C324-408C-99F3-5E76E73DECF8}"/>
                </a:ext>
              </a:extLst>
            </p:cNvPr>
            <p:cNvGraphicFramePr/>
            <p:nvPr/>
          </p:nvGraphicFramePr>
          <p:xfrm>
            <a:off x="5803900" y="18703"/>
            <a:ext cx="7196004" cy="39369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200D921-A145-4FD3-AB7A-D3ED85B5701E}"/>
                </a:ext>
              </a:extLst>
            </p:cNvPr>
            <p:cNvSpPr txBox="1"/>
            <p:nvPr/>
          </p:nvSpPr>
          <p:spPr>
            <a:xfrm>
              <a:off x="606425" y="4521565"/>
              <a:ext cx="11315700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defTabSz="914400" rtl="0" eaLnBrk="1" fontAlgn="auto" latinLnBrk="0" hangingPunct="1"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b="1" dirty="0">
                  <a:solidFill>
                    <a:srgbClr val="177CB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ry Figure2. The basic information of the included studies</a:t>
              </a:r>
            </a:p>
            <a:p>
              <a:pPr>
                <a:defRPr/>
              </a:pPr>
              <a:r>
                <a:rPr lang="en-US" altLang="zh-CN" dirty="0">
                  <a:solidFill>
                    <a:srgbClr val="177CB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. The annual distribution of included studies.  B. The institution distribution of included studies.</a:t>
              </a:r>
            </a:p>
          </p:txBody>
        </p: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97337175-579F-4D46-8E39-13E280A84EC1}"/>
                </a:ext>
              </a:extLst>
            </p:cNvPr>
            <p:cNvGrpSpPr/>
            <p:nvPr/>
          </p:nvGrpSpPr>
          <p:grpSpPr>
            <a:xfrm>
              <a:off x="5767650" y="3822074"/>
              <a:ext cx="730250" cy="369332"/>
              <a:chOff x="5721350" y="3914674"/>
              <a:chExt cx="730250" cy="369332"/>
            </a:xfrm>
          </p:grpSpPr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9ED4CE7B-88ED-4FD0-AFF9-57E808B1B36C}"/>
                  </a:ext>
                </a:extLst>
              </p:cNvPr>
              <p:cNvSpPr txBox="1"/>
              <p:nvPr/>
            </p:nvSpPr>
            <p:spPr>
              <a:xfrm>
                <a:off x="5721350" y="3914674"/>
                <a:ext cx="37465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dirty="0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C57AF47B-18F3-4690-8ABD-C661AA1D46D3}"/>
                  </a:ext>
                </a:extLst>
              </p:cNvPr>
              <p:cNvSpPr txBox="1"/>
              <p:nvPr/>
            </p:nvSpPr>
            <p:spPr>
              <a:xfrm>
                <a:off x="6076950" y="3914674"/>
                <a:ext cx="37465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dirty="0"/>
              </a:p>
            </p:txBody>
          </p:sp>
        </p:grp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A88C5C45-30D5-4269-BBAD-298A754D8737}"/>
                </a:ext>
              </a:extLst>
            </p:cNvPr>
            <p:cNvCxnSpPr>
              <a:cxnSpLocks/>
            </p:cNvCxnSpPr>
            <p:nvPr/>
          </p:nvCxnSpPr>
          <p:spPr>
            <a:xfrm>
              <a:off x="5677865" y="3823076"/>
              <a:ext cx="927422" cy="0"/>
            </a:xfrm>
            <a:prstGeom prst="line">
              <a:avLst/>
            </a:prstGeom>
            <a:ln>
              <a:solidFill>
                <a:srgbClr val="177CB0"/>
              </a:solidFill>
              <a:prstDash val="dash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66D69F89-07F3-4543-B44D-F828DB9CED13}"/>
                </a:ext>
              </a:extLst>
            </p:cNvPr>
            <p:cNvCxnSpPr>
              <a:cxnSpLocks/>
            </p:cNvCxnSpPr>
            <p:nvPr/>
          </p:nvCxnSpPr>
          <p:spPr>
            <a:xfrm>
              <a:off x="6118442" y="3227251"/>
              <a:ext cx="0" cy="595825"/>
            </a:xfrm>
            <a:prstGeom prst="line">
              <a:avLst/>
            </a:prstGeom>
            <a:ln>
              <a:solidFill>
                <a:srgbClr val="177CB0"/>
              </a:solidFill>
              <a:prstDash val="dash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46848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 Black-Arial">
    <a:majorFont>
      <a:latin typeface="Arial Black"/>
      <a:ea typeface=""/>
      <a:cs typeface=""/>
      <a:font script="Jpan" typeface="ＭＳ ゴシック"/>
      <a:font script="Hang" typeface="굴림"/>
      <a:font script="Hans" typeface="宋体"/>
      <a:font script="Hant" typeface="新細明體"/>
      <a:font script="Arab" typeface="Tahoma"/>
      <a:font script="Hebr" typeface="Tahoma"/>
      <a:font script="Thai" typeface="FreesiaUPC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Verdana"/>
      <a:font script="Uigh" typeface="Microsoft Uighur"/>
      <a:font script="Geor" typeface="Sylfaen"/>
    </a:majorFont>
    <a:minorFont>
      <a:latin typeface="Arial"/>
      <a:ea typeface=""/>
      <a:cs typeface=""/>
      <a:font script="Jpan" typeface="ＭＳ Ｐゴシック"/>
      <a:font script="Hang" typeface="굴림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</Words>
  <Application>Microsoft Office PowerPoint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dai .</dc:creator>
  <cp:lastModifiedBy>Madai .</cp:lastModifiedBy>
  <cp:revision>2</cp:revision>
  <dcterms:created xsi:type="dcterms:W3CDTF">2021-10-14T22:44:13Z</dcterms:created>
  <dcterms:modified xsi:type="dcterms:W3CDTF">2021-10-14T22:46:58Z</dcterms:modified>
</cp:coreProperties>
</file>